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96" y="4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91138DE-C541-480F-A099-B7C03A882145}" type="datetimeFigureOut">
              <a:rPr lang="en-GB" smtClean="0"/>
              <a:t>14/10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EF06627-A05F-4695-87BC-EA56DD5E88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09255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EF06627-A05F-4695-87BC-EA56DD5E889C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54495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1DC6A4-14B4-4BCF-4F01-08EA1F892CF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B41A55C-6D74-FC6A-4172-2C1616EE8AC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6CD4C7-3260-0FCB-68BF-32C09E0972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2463C-9B2E-497E-8F4A-3132644A690F}" type="datetimeFigureOut">
              <a:rPr lang="en-GB" smtClean="0"/>
              <a:t>14/10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354A4C-9C61-A9AB-7392-B861BA0951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DFACDC-028D-5AD0-4546-2992FECC42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555DF-9062-4F9D-8415-DD7A63CD54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66157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6B76CA-2D7D-D091-292E-5ECA2A9668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92665B2-EAC8-DEC4-FC7E-29B7267E185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83A174-09A6-AC36-E186-C6FF53818E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2463C-9B2E-497E-8F4A-3132644A690F}" type="datetimeFigureOut">
              <a:rPr lang="en-GB" smtClean="0"/>
              <a:t>14/10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251B9A-49D6-2F39-BBBD-813E811CC5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48748F-670F-F449-72AD-A8513A8A74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555DF-9062-4F9D-8415-DD7A63CD54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85775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54EBF02-FC36-5A97-4286-B811430280E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54560BD-D139-0D81-9CDE-9AEBD2BAFD5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408BE1-FF15-915B-569A-C49DCFDF2D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2463C-9B2E-497E-8F4A-3132644A690F}" type="datetimeFigureOut">
              <a:rPr lang="en-GB" smtClean="0"/>
              <a:t>14/10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8E85B4-E97B-6C6B-40A0-35C3C4AF1B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99430B-9F70-4FE6-19D4-D0B0BC33B8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555DF-9062-4F9D-8415-DD7A63CD54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07185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D4D842-C4E8-9502-1A99-0FC7E203AD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53AB4BC-A39E-2BCD-4E78-822353F4905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0905EF-384F-0DAE-AB85-394F542714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2463C-9B2E-497E-8F4A-3132644A690F}" type="datetimeFigureOut">
              <a:rPr lang="en-GB" smtClean="0"/>
              <a:t>14/10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F8C9F9-EF91-A27D-F1CC-458F164D62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65D182-5C06-43C9-77F9-5880F0615C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555DF-9062-4F9D-8415-DD7A63CD54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16849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38ECCA-1EDF-5F71-7EE2-2EE419D757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362276D-E4A8-2018-F82D-05CFAD2106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3D7C83-0277-6425-9B7D-2C262FDDBB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2463C-9B2E-497E-8F4A-3132644A690F}" type="datetimeFigureOut">
              <a:rPr lang="en-GB" smtClean="0"/>
              <a:t>14/10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553DAF-CF40-8FE8-71E6-77579950FD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DBCF2B-0F33-3351-A120-9E08360289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555DF-9062-4F9D-8415-DD7A63CD54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19595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383186-CFF8-A8BB-AC42-59D1F0E8A8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6616634-FA1A-FBAC-61DD-BB008C1B503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76FB0AE-8F84-74A3-D9EF-BB4905B0D77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1D16DDA-A11B-2954-8EBA-7F6A9DBC98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2463C-9B2E-497E-8F4A-3132644A690F}" type="datetimeFigureOut">
              <a:rPr lang="en-GB" smtClean="0"/>
              <a:t>14/10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E2E14F7-1C43-E3CE-0CE4-CB881A7429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2F00D70-19BE-14E1-0C10-E06376CD5A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555DF-9062-4F9D-8415-DD7A63CD54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39112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A16CAD-F37E-7A34-7028-2169F50846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3D57897-1F9D-2B20-E483-C5243B2E28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408B30F-1C26-1D2E-2C79-12939C87F5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E1FB5D5-B985-F2BF-F7B5-3C9E1645801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5982E79-CB4C-4922-B1CF-24131737AB3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683B15C-E74C-A731-36B9-456CEFC4CF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2463C-9B2E-497E-8F4A-3132644A690F}" type="datetimeFigureOut">
              <a:rPr lang="en-GB" smtClean="0"/>
              <a:t>14/10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34718DB-683B-CE4B-A8E3-1E5BC07433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068FE8A-947B-0582-8545-57FAA04EF3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555DF-9062-4F9D-8415-DD7A63CD54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1358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01CB7D-AB2A-F30B-BC05-7C645E964B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7D888A8-A422-BDFB-1D60-FDEEC69BA3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2463C-9B2E-497E-8F4A-3132644A690F}" type="datetimeFigureOut">
              <a:rPr lang="en-GB" smtClean="0"/>
              <a:t>14/10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A6F59D4-5DDC-09E1-EC13-AF0DD1C9F2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6D12D69-537B-DD3F-AA17-C2842C2E77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555DF-9062-4F9D-8415-DD7A63CD54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93514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5173AD0-A5A9-F75A-70E0-7DEC6C7797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2463C-9B2E-497E-8F4A-3132644A690F}" type="datetimeFigureOut">
              <a:rPr lang="en-GB" smtClean="0"/>
              <a:t>14/10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77213A3-D1ED-5C72-70E7-22E9ACB728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FD3301E-38FF-B02D-9938-FE7E565C38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555DF-9062-4F9D-8415-DD7A63CD54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62531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4F6097-9B4A-D26E-2F3E-88E0EE5763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6DE573C-F5C5-E223-A27E-E2C856E7A18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8E1E443-B288-36DD-0E3F-1CC71A5EEAC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1384BF0-1E61-B631-E3BB-D90BB0E753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2463C-9B2E-497E-8F4A-3132644A690F}" type="datetimeFigureOut">
              <a:rPr lang="en-GB" smtClean="0"/>
              <a:t>14/10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8E1F9E7-E812-D385-38BD-65B4B162AC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CFE2107-147A-D7BC-1EE8-74229A9716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555DF-9062-4F9D-8415-DD7A63CD54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16818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FB854E-DC3F-D861-F2B5-1D5DB5F4ED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F818235-E895-CE15-C601-5DB8F897D09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2AA8108-568F-76D6-D4FE-11A36121CCB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D3025DC-7A2F-9F5E-0CEF-CC5B149000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2463C-9B2E-497E-8F4A-3132644A690F}" type="datetimeFigureOut">
              <a:rPr lang="en-GB" smtClean="0"/>
              <a:t>14/10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895E9FE-E571-E477-3173-F4F0629DBB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F13311A-BD36-CEA6-E67A-D291204B88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555DF-9062-4F9D-8415-DD7A63CD54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81969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9CBCF3F-A946-CBC5-28B8-DD389A2A5C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DFF56C-E98E-E003-1167-FFC425D345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A93199-6CA1-0C6D-9F5E-0D57B0636FB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3E2463C-9B2E-497E-8F4A-3132644A690F}" type="datetimeFigureOut">
              <a:rPr lang="en-GB" smtClean="0"/>
              <a:t>14/10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B84458-0BC6-A2AF-6341-0A573461B01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71CCA5-A958-AFFF-45FB-23F6186DAF0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7F555DF-9062-4F9D-8415-DD7A63CD54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90836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EE9CFF73-5095-D59C-4E70-0B1563FD687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2951" y="0"/>
            <a:ext cx="10786098" cy="648313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05421655-CE75-4860-A2B9-D670DD8D9188}"/>
              </a:ext>
            </a:extLst>
          </p:cNvPr>
          <p:cNvSpPr txBox="1"/>
          <p:nvPr/>
        </p:nvSpPr>
        <p:spPr>
          <a:xfrm>
            <a:off x="2830285" y="6560323"/>
            <a:ext cx="6531429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sz="1200" dirty="0"/>
              <a:t>Supplementary Figure 1. Top three TMFs (most often utilised in sample) mapped across time</a:t>
            </a:r>
          </a:p>
        </p:txBody>
      </p:sp>
    </p:spTree>
    <p:extLst>
      <p:ext uri="{BB962C8B-B14F-4D97-AF65-F5344CB8AC3E}">
        <p14:creationId xmlns:p14="http://schemas.microsoft.com/office/powerpoint/2010/main" val="11167086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F610C44C-9E7C-0A2D-1A12-DFB64F0AD44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662048"/>
            <a:ext cx="12182360" cy="5533903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DDF8B1A4-7FCC-65E9-43F6-D86A84F762F5}"/>
              </a:ext>
            </a:extLst>
          </p:cNvPr>
          <p:cNvSpPr txBox="1"/>
          <p:nvPr/>
        </p:nvSpPr>
        <p:spPr>
          <a:xfrm>
            <a:off x="2372224" y="6394068"/>
            <a:ext cx="7437911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sz="1200" dirty="0"/>
              <a:t>Supplementary Figure 2. Breakdown of which TMFs are used in publications focusing on underserved groups </a:t>
            </a:r>
          </a:p>
        </p:txBody>
      </p:sp>
    </p:spTree>
    <p:extLst>
      <p:ext uri="{BB962C8B-B14F-4D97-AF65-F5344CB8AC3E}">
        <p14:creationId xmlns:p14="http://schemas.microsoft.com/office/powerpoint/2010/main" val="29579645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34</Words>
  <Application>Microsoft Office PowerPoint</Application>
  <PresentationFormat>Widescreen</PresentationFormat>
  <Paragraphs>3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offey, Taylor</dc:creator>
  <cp:lastModifiedBy>Coffey, Taylor</cp:lastModifiedBy>
  <cp:revision>2</cp:revision>
  <dcterms:created xsi:type="dcterms:W3CDTF">2024-10-14T09:21:45Z</dcterms:created>
  <dcterms:modified xsi:type="dcterms:W3CDTF">2024-10-14T09:25:36Z</dcterms:modified>
</cp:coreProperties>
</file>